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C37B0-5809-4FD4-8A95-BEB8B936CB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F3DF3-8B71-41A0-B3EB-5D6EF5EA2D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D3DE1A-1740-4CF4-95F7-C2C8738E08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E2927-F9E3-4D04-BAC7-0E65E9362C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17A45-8594-4A24-8C42-3DC368201A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21CD2-1A91-4713-BDE7-2EFF37868C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157BC-5253-44B4-9AB3-801C8E8039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907F6C-3642-4DEC-A31F-A6D990530C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46279-2E8D-4B51-B7F8-3ECE09FC3A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1721A-8EBB-4C4F-B3C7-C50E72B92E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3A863-E373-47F2-B604-7CFC21E586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1D378-CE20-4846-AA50-B794D3D7AE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20BA34-CD34-4446-A617-344CD93C67D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45315" t="0" r="13898" b="11333"/>
          <a:stretch/>
        </p:blipFill>
        <p:spPr>
          <a:xfrm>
            <a:off x="1679400" y="690480"/>
            <a:ext cx="660600" cy="15843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614960" y="2281320"/>
            <a:ext cx="275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877760" y="228276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139840" y="2281320"/>
            <a:ext cx="244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349360" y="1108080"/>
            <a:ext cx="76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349360" y="1886040"/>
            <a:ext cx="76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351520" y="990720"/>
            <a:ext cx="3607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lox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351520" y="1774800"/>
            <a:ext cx="43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lox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27360" y="1028880"/>
            <a:ext cx="203400" cy="96984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624120" y="1025640"/>
            <a:ext cx="204840" cy="969840"/>
          </a:xfrm>
          <a:prstGeom prst="rect">
            <a:avLst/>
          </a:prstGeom>
          <a:noFill/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33880" y="1271520"/>
            <a:ext cx="201600" cy="7272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130640" y="1268280"/>
            <a:ext cx="203400" cy="727200"/>
          </a:xfrm>
          <a:prstGeom prst="rect">
            <a:avLst/>
          </a:prstGeom>
          <a:noFill/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3726000" y="1009800"/>
            <a:ext cx="1440" cy="15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710160" y="1009800"/>
            <a:ext cx="3312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4232160" y="1214280"/>
            <a:ext cx="1800" cy="54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216320" y="1214280"/>
            <a:ext cx="3348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726000" y="1025640"/>
            <a:ext cx="1440" cy="15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710160" y="1041480"/>
            <a:ext cx="3312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232160" y="1268280"/>
            <a:ext cx="1800" cy="54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216320" y="1322280"/>
            <a:ext cx="3348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476520" y="835200"/>
            <a:ext cx="14400" cy="1163520"/>
          </a:xfrm>
          <a:custGeom>
            <a:avLst/>
            <a:gdLst/>
            <a:ahLst/>
            <a:rect l="l" t="t" r="r" b="b"/>
            <a:pathLst>
              <a:path w="9" h="733">
                <a:moveTo>
                  <a:pt x="0" y="0"/>
                </a:moveTo>
                <a:lnTo>
                  <a:pt x="0" y="733"/>
                </a:lnTo>
                <a:lnTo>
                  <a:pt x="9" y="733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476520" y="1803240"/>
            <a:ext cx="144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476520" y="1609560"/>
            <a:ext cx="144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476520" y="1415880"/>
            <a:ext cx="144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476520" y="1222200"/>
            <a:ext cx="14400" cy="180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476520" y="1028880"/>
            <a:ext cx="144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476520" y="835200"/>
            <a:ext cx="14400" cy="1440"/>
          </a:xfrm>
          <a:prstGeom prst="line">
            <a:avLst/>
          </a:prstGeom>
          <a:ln w="1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476520" y="1998720"/>
            <a:ext cx="1011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377880" y="19382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271680" y="17445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271680" y="1550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271680" y="13557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271680" y="11620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271680" y="968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271680" y="77472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2503800" y="1351800"/>
            <a:ext cx="12837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RNA fold chan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553920" y="2017800"/>
            <a:ext cx="37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909600" y="2031840"/>
            <a:ext cx="651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ol-Cre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gfr</a:t>
            </a:r>
            <a:r>
              <a:rPr b="0" i="1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f/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55720" y="2649600"/>
            <a:ext cx="74800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upplemental figure. The CRE activity from Col-Cr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gfr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</a:rPr>
              <a:t>f/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mice does not completely delete the floxed EGFR allele in the osteoblastic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imary calvarial osteoblastic cells from Col-Cr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gfr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</a:rPr>
              <a:t>f/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wild type mice were cultured in vitro. (A) Genomic DNAs were extracted from these cells and genotyping was performed to detect both flox (1105 bp) and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lox (234 bp) alleles. M: molecular markers; Lane 1: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gfr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</a:rPr>
              <a:t>f/f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; lane 2: Col-Cre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gfr</a:t>
            </a:r>
            <a:r>
              <a:rPr b="0" i="1" lang="en-US" sz="1200" spc="-1" strike="noStrike" baseline="30000">
                <a:solidFill>
                  <a:srgbClr val="000000"/>
                </a:solidFill>
                <a:latin typeface="Arial"/>
              </a:rPr>
              <a:t>f/f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B) RNAs were harvested from these cells and subjected to realtime RT-PCR with primers specifically detecting EGFR exon 3 which is flanked by two loxP sit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587600" y="1989000"/>
            <a:ext cx="75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587600" y="1809720"/>
            <a:ext cx="75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587600" y="1144440"/>
            <a:ext cx="759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258200" y="1031760"/>
            <a:ext cx="398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 k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162440" y="1676520"/>
            <a:ext cx="49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3 k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162440" y="1873080"/>
            <a:ext cx="49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.2 k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144080" y="5238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871360" y="523800"/>
            <a:ext cx="31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6-08T21:10:33Z</dcterms:created>
  <dc:creator>SOM IS</dc:creator>
  <dc:description/>
  <dc:language>en-US</dc:language>
  <cp:lastModifiedBy>Qin Ling</cp:lastModifiedBy>
  <cp:lastPrinted>2010-08-20T16:09:51Z</cp:lastPrinted>
  <dcterms:modified xsi:type="dcterms:W3CDTF">2010-08-22T19:17:23Z</dcterms:modified>
  <cp:revision>8</cp:revision>
  <dc:subject/>
  <dc:title>PowerPoint Presentation</dc:title>
</cp:coreProperties>
</file>